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66" r:id="rId2"/>
    <p:sldId id="267" r:id="rId3"/>
    <p:sldId id="268" r:id="rId4"/>
    <p:sldId id="262" r:id="rId5"/>
    <p:sldId id="265" r:id="rId6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643"/>
    <p:restoredTop sz="95843"/>
  </p:normalViewPr>
  <p:slideViewPr>
    <p:cSldViewPr snapToGrid="0" snapToObjects="1">
      <p:cViewPr varScale="1">
        <p:scale>
          <a:sx n="78" d="100"/>
          <a:sy n="78" d="100"/>
        </p:scale>
        <p:origin x="3702" y="9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54FBD1-509D-3546-9BB4-45476DF1A2A1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5EE2D1-2D72-6240-8982-87EB14F93D0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62094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3136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1083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5846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8399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8337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1972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6854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9204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954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2513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7292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3A42C-4AD7-8848-8C7E-654882745BA8}" type="datetimeFigureOut">
              <a:rPr lang="it-IT" smtClean="0"/>
              <a:t>13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514545-988D-4D4F-B105-4847BEFE14C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3931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emf"/><Relationship Id="rId11" Type="http://schemas.openxmlformats.org/officeDocument/2006/relationships/image" Target="../media/image14.emf"/><Relationship Id="rId5" Type="http://schemas.openxmlformats.org/officeDocument/2006/relationships/image" Target="../media/image8.emf"/><Relationship Id="rId10" Type="http://schemas.openxmlformats.org/officeDocument/2006/relationships/image" Target="../media/image13.emf"/><Relationship Id="rId4" Type="http://schemas.openxmlformats.org/officeDocument/2006/relationships/image" Target="../media/image7.emf"/><Relationship Id="rId9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image" Target="../media/image16.emf"/><Relationship Id="rId7" Type="http://schemas.openxmlformats.org/officeDocument/2006/relationships/image" Target="../media/image20.emf"/><Relationship Id="rId12" Type="http://schemas.openxmlformats.org/officeDocument/2006/relationships/image" Target="../media/image25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11" Type="http://schemas.openxmlformats.org/officeDocument/2006/relationships/image" Target="../media/image24.emf"/><Relationship Id="rId5" Type="http://schemas.openxmlformats.org/officeDocument/2006/relationships/image" Target="../media/image18.emf"/><Relationship Id="rId10" Type="http://schemas.openxmlformats.org/officeDocument/2006/relationships/image" Target="../media/image23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emf"/><Relationship Id="rId13" Type="http://schemas.openxmlformats.org/officeDocument/2006/relationships/image" Target="../media/image37.emf"/><Relationship Id="rId18" Type="http://schemas.openxmlformats.org/officeDocument/2006/relationships/image" Target="../media/image42.emf"/><Relationship Id="rId26" Type="http://schemas.openxmlformats.org/officeDocument/2006/relationships/image" Target="../media/image50.emf"/><Relationship Id="rId3" Type="http://schemas.openxmlformats.org/officeDocument/2006/relationships/image" Target="../media/image27.emf"/><Relationship Id="rId21" Type="http://schemas.openxmlformats.org/officeDocument/2006/relationships/image" Target="../media/image45.emf"/><Relationship Id="rId7" Type="http://schemas.openxmlformats.org/officeDocument/2006/relationships/image" Target="../media/image31.emf"/><Relationship Id="rId12" Type="http://schemas.openxmlformats.org/officeDocument/2006/relationships/image" Target="../media/image36.emf"/><Relationship Id="rId17" Type="http://schemas.openxmlformats.org/officeDocument/2006/relationships/image" Target="../media/image41.emf"/><Relationship Id="rId25" Type="http://schemas.openxmlformats.org/officeDocument/2006/relationships/image" Target="../media/image49.emf"/><Relationship Id="rId2" Type="http://schemas.openxmlformats.org/officeDocument/2006/relationships/image" Target="../media/image26.emf"/><Relationship Id="rId16" Type="http://schemas.openxmlformats.org/officeDocument/2006/relationships/image" Target="../media/image40.emf"/><Relationship Id="rId20" Type="http://schemas.openxmlformats.org/officeDocument/2006/relationships/image" Target="../media/image44.emf"/><Relationship Id="rId29" Type="http://schemas.openxmlformats.org/officeDocument/2006/relationships/image" Target="../media/image5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emf"/><Relationship Id="rId11" Type="http://schemas.openxmlformats.org/officeDocument/2006/relationships/image" Target="../media/image35.emf"/><Relationship Id="rId24" Type="http://schemas.openxmlformats.org/officeDocument/2006/relationships/image" Target="../media/image48.emf"/><Relationship Id="rId5" Type="http://schemas.openxmlformats.org/officeDocument/2006/relationships/image" Target="../media/image29.emf"/><Relationship Id="rId15" Type="http://schemas.openxmlformats.org/officeDocument/2006/relationships/image" Target="../media/image39.emf"/><Relationship Id="rId23" Type="http://schemas.openxmlformats.org/officeDocument/2006/relationships/image" Target="../media/image47.emf"/><Relationship Id="rId28" Type="http://schemas.openxmlformats.org/officeDocument/2006/relationships/image" Target="../media/image52.emf"/><Relationship Id="rId10" Type="http://schemas.openxmlformats.org/officeDocument/2006/relationships/image" Target="../media/image34.emf"/><Relationship Id="rId19" Type="http://schemas.openxmlformats.org/officeDocument/2006/relationships/image" Target="../media/image43.emf"/><Relationship Id="rId31" Type="http://schemas.openxmlformats.org/officeDocument/2006/relationships/image" Target="../media/image55.emf"/><Relationship Id="rId4" Type="http://schemas.openxmlformats.org/officeDocument/2006/relationships/image" Target="../media/image28.emf"/><Relationship Id="rId9" Type="http://schemas.openxmlformats.org/officeDocument/2006/relationships/image" Target="../media/image33.emf"/><Relationship Id="rId14" Type="http://schemas.openxmlformats.org/officeDocument/2006/relationships/image" Target="../media/image38.emf"/><Relationship Id="rId22" Type="http://schemas.openxmlformats.org/officeDocument/2006/relationships/image" Target="../media/image46.emf"/><Relationship Id="rId27" Type="http://schemas.openxmlformats.org/officeDocument/2006/relationships/image" Target="../media/image51.emf"/><Relationship Id="rId30" Type="http://schemas.openxmlformats.org/officeDocument/2006/relationships/image" Target="../media/image54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emf"/><Relationship Id="rId13" Type="http://schemas.openxmlformats.org/officeDocument/2006/relationships/image" Target="../media/image67.emf"/><Relationship Id="rId18" Type="http://schemas.openxmlformats.org/officeDocument/2006/relationships/image" Target="../media/image72.emf"/><Relationship Id="rId26" Type="http://schemas.openxmlformats.org/officeDocument/2006/relationships/image" Target="../media/image80.emf"/><Relationship Id="rId3" Type="http://schemas.openxmlformats.org/officeDocument/2006/relationships/image" Target="../media/image57.emf"/><Relationship Id="rId21" Type="http://schemas.openxmlformats.org/officeDocument/2006/relationships/image" Target="../media/image75.emf"/><Relationship Id="rId7" Type="http://schemas.openxmlformats.org/officeDocument/2006/relationships/image" Target="../media/image61.emf"/><Relationship Id="rId12" Type="http://schemas.openxmlformats.org/officeDocument/2006/relationships/image" Target="../media/image66.emf"/><Relationship Id="rId17" Type="http://schemas.openxmlformats.org/officeDocument/2006/relationships/image" Target="../media/image71.emf"/><Relationship Id="rId25" Type="http://schemas.openxmlformats.org/officeDocument/2006/relationships/image" Target="../media/image79.emf"/><Relationship Id="rId2" Type="http://schemas.openxmlformats.org/officeDocument/2006/relationships/image" Target="../media/image56.emf"/><Relationship Id="rId16" Type="http://schemas.openxmlformats.org/officeDocument/2006/relationships/image" Target="../media/image70.emf"/><Relationship Id="rId20" Type="http://schemas.openxmlformats.org/officeDocument/2006/relationships/image" Target="../media/image74.emf"/><Relationship Id="rId29" Type="http://schemas.openxmlformats.org/officeDocument/2006/relationships/image" Target="../media/image8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emf"/><Relationship Id="rId11" Type="http://schemas.openxmlformats.org/officeDocument/2006/relationships/image" Target="../media/image65.emf"/><Relationship Id="rId24" Type="http://schemas.openxmlformats.org/officeDocument/2006/relationships/image" Target="../media/image78.emf"/><Relationship Id="rId5" Type="http://schemas.openxmlformats.org/officeDocument/2006/relationships/image" Target="../media/image59.emf"/><Relationship Id="rId15" Type="http://schemas.openxmlformats.org/officeDocument/2006/relationships/image" Target="../media/image69.emf"/><Relationship Id="rId23" Type="http://schemas.openxmlformats.org/officeDocument/2006/relationships/image" Target="../media/image77.emf"/><Relationship Id="rId28" Type="http://schemas.openxmlformats.org/officeDocument/2006/relationships/image" Target="../media/image82.emf"/><Relationship Id="rId10" Type="http://schemas.openxmlformats.org/officeDocument/2006/relationships/image" Target="../media/image64.emf"/><Relationship Id="rId19" Type="http://schemas.openxmlformats.org/officeDocument/2006/relationships/image" Target="../media/image73.emf"/><Relationship Id="rId31" Type="http://schemas.openxmlformats.org/officeDocument/2006/relationships/image" Target="../media/image85.emf"/><Relationship Id="rId4" Type="http://schemas.openxmlformats.org/officeDocument/2006/relationships/image" Target="../media/image58.emf"/><Relationship Id="rId9" Type="http://schemas.openxmlformats.org/officeDocument/2006/relationships/image" Target="../media/image63.emf"/><Relationship Id="rId14" Type="http://schemas.openxmlformats.org/officeDocument/2006/relationships/image" Target="../media/image68.emf"/><Relationship Id="rId22" Type="http://schemas.openxmlformats.org/officeDocument/2006/relationships/image" Target="../media/image76.emf"/><Relationship Id="rId27" Type="http://schemas.openxmlformats.org/officeDocument/2006/relationships/image" Target="../media/image81.emf"/><Relationship Id="rId30" Type="http://schemas.openxmlformats.org/officeDocument/2006/relationships/image" Target="../media/image8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191DEA03-5806-DD44-A407-CBD43B3069DF}"/>
              </a:ext>
            </a:extLst>
          </p:cNvPr>
          <p:cNvSpPr txBox="1"/>
          <p:nvPr/>
        </p:nvSpPr>
        <p:spPr>
          <a:xfrm>
            <a:off x="75646" y="9625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0F611E8D-68D8-DF4D-9227-6E1C06D6344A}"/>
              </a:ext>
            </a:extLst>
          </p:cNvPr>
          <p:cNvSpPr txBox="1"/>
          <p:nvPr/>
        </p:nvSpPr>
        <p:spPr>
          <a:xfrm>
            <a:off x="3366000" y="988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C840668D-856B-C144-9B45-86C96D86E149}"/>
              </a:ext>
            </a:extLst>
          </p:cNvPr>
          <p:cNvSpPr txBox="1"/>
          <p:nvPr/>
        </p:nvSpPr>
        <p:spPr>
          <a:xfrm>
            <a:off x="96730" y="301505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19EED9EC-B909-4146-9528-53D323793253}"/>
              </a:ext>
            </a:extLst>
          </p:cNvPr>
          <p:cNvSpPr txBox="1"/>
          <p:nvPr/>
        </p:nvSpPr>
        <p:spPr>
          <a:xfrm>
            <a:off x="3387084" y="301505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7E5CF823-BE0E-FA45-B7B2-E7AE44B69DBE}"/>
              </a:ext>
            </a:extLst>
          </p:cNvPr>
          <p:cNvSpPr/>
          <p:nvPr/>
        </p:nvSpPr>
        <p:spPr>
          <a:xfrm>
            <a:off x="116059" y="7492106"/>
            <a:ext cx="6661330" cy="22929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1. </a:t>
            </a:r>
            <a:r>
              <a:rPr lang="en-GB" sz="11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oprotection</a:t>
            </a:r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for I</a:t>
            </a:r>
            <a:r>
              <a:rPr lang="en-US" sz="1100" b="1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fluenza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ccine strains in healthy and type 2 diabetes mellitus (T2D) vaccine recipients. 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-D)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</a:t>
            </a:r>
            <a:r>
              <a:rPr lang="en-GB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roprotection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ate was evaluated for all the vaccine antigen components included in the </a:t>
            </a:r>
            <a:r>
              <a:rPr lang="en-GB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celvax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Quadrivalent Influenza vaccine used in the 2021/2022 season (A/Wisconsin, A/Cambodia, B/Phuket and B/Washington) to </a:t>
            </a:r>
            <a:r>
              <a:rPr lang="en-GB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alyze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he influenza (Flu) vaccine immunogenicity in the study groups.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particular,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percentage of vaccine recipients with a post-vaccination </a:t>
            </a:r>
            <a:r>
              <a:rPr lang="en-GB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aemagglutination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hibition (HAI) </a:t>
            </a:r>
            <a:r>
              <a:rPr lang="en-GB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ters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at least 1:40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evels of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pecific anti-Flu antibodies was calculated from data collected in sera from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nly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 (in grey) and 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lus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s (in blue for healthy subjects, HS; in petrol green for T2D individuals) before (day 0, d0) and 30 days (d30) after the 3</a:t>
            </a:r>
            <a:r>
              <a:rPr lang="en-US" sz="11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d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ooster dose of anti-COVID-19 mRNA vaccine in presence or absence of anti-Flu vaccine. In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efore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 (in light blue)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oprotection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as calculated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efore (d0) quadrivalent anti-Flu vaccine, as well as before (d30), and 30 days after the 3</a:t>
            </a:r>
            <a:r>
              <a:rPr lang="en-US" sz="11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d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ooster dose of anti-COVID-19 mRNA vaccine (d30+30). P-values calculated by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ne-way ANOVA test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 assigned as follows: * ≤ 0.05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DCB4EDBE-66A3-1942-BCAD-CAF0453131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730" y="295654"/>
            <a:ext cx="3034595" cy="2520000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F710D600-C99C-634E-BA61-0BDB07D1C7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6724" y="274050"/>
            <a:ext cx="2912161" cy="2520000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96674478-8439-4B49-B147-0011315073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730" y="3190545"/>
            <a:ext cx="3071490" cy="2520000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86EF9369-D124-3843-957E-47373BB110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7396" y="3168941"/>
            <a:ext cx="3043735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51683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ttangolo 14">
            <a:extLst>
              <a:ext uri="{FF2B5EF4-FFF2-40B4-BE49-F238E27FC236}">
                <a16:creationId xmlns:a16="http://schemas.microsoft.com/office/drawing/2014/main" id="{27DEF37E-4381-ED4A-B6C5-586588CD5A05}"/>
              </a:ext>
            </a:extLst>
          </p:cNvPr>
          <p:cNvSpPr/>
          <p:nvPr/>
        </p:nvSpPr>
        <p:spPr>
          <a:xfrm>
            <a:off x="96695" y="7810526"/>
            <a:ext cx="6687747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2. Regulation of circulating metabolites (aqueous fraction) in healthy and type 2 diabetes mellitus (T2D) individuals receiving anti-Influenza and anti-COVID-19 vaccination.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anges in metabolite levels of the aqueous fraction were measured in  serum samples longitudinally collected in fasting condition from 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nly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 (in grey) and 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lus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s (in blue for healthy subjects, HS; in petrol green for T2D individuals) immediately before (day 0, d0), as well as 1 day and 30 days (d1 and d30, respectively) after the 3rd booster dose of anti-COVID-19 mRNA vaccine in presence or absence of anti-Flu vaccine. Only for 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efore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 (in light blue) the analysis was performed on sera stored before (d0) quadrivalent anti-Flu vaccine, as well as before (d30) and 1 and 30 days after (d30+1 and d30+30, respectively) the 3rd booster dose of anti-COVID-19 mRNA vaccine. Values are shown as percentage (%) of the metabolite level relative to total metabolites. P-values calculated by one-way ANOVA test were assigned as follows: * ≤ 0.05; ** ≤ 0.01; *** ≤ 0.001, **** ≤ 0.0001.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17" name="Immagine 16">
            <a:extLst>
              <a:ext uri="{FF2B5EF4-FFF2-40B4-BE49-F238E27FC236}">
                <a16:creationId xmlns:a16="http://schemas.microsoft.com/office/drawing/2014/main" id="{0CDD8A14-EBAF-5A4B-A04F-D781F29E2A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747" y="2182241"/>
            <a:ext cx="1984500" cy="1800000"/>
          </a:xfrm>
          <a:prstGeom prst="rect">
            <a:avLst/>
          </a:prstGeom>
        </p:spPr>
      </p:pic>
      <p:pic>
        <p:nvPicPr>
          <p:cNvPr id="18" name="Immagine 17">
            <a:extLst>
              <a:ext uri="{FF2B5EF4-FFF2-40B4-BE49-F238E27FC236}">
                <a16:creationId xmlns:a16="http://schemas.microsoft.com/office/drawing/2014/main" id="{4884767F-D377-374A-ACE2-9DF6CAE681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1354" y="2182241"/>
            <a:ext cx="1918248" cy="1800000"/>
          </a:xfrm>
          <a:prstGeom prst="rect">
            <a:avLst/>
          </a:prstGeom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67F3A6A7-CBE9-A843-8E6E-1399ED0B29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93319" y="2182241"/>
            <a:ext cx="1948872" cy="1800000"/>
          </a:xfrm>
          <a:prstGeom prst="rect">
            <a:avLst/>
          </a:prstGeom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4BE6473C-1FEA-8E4F-BC22-F3ECABFB57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0828" y="4096383"/>
            <a:ext cx="1984500" cy="1800000"/>
          </a:xfrm>
          <a:prstGeom prst="rect">
            <a:avLst/>
          </a:prstGeom>
        </p:spPr>
      </p:pic>
      <p:pic>
        <p:nvPicPr>
          <p:cNvPr id="21" name="Immagine 20">
            <a:extLst>
              <a:ext uri="{FF2B5EF4-FFF2-40B4-BE49-F238E27FC236}">
                <a16:creationId xmlns:a16="http://schemas.microsoft.com/office/drawing/2014/main" id="{C1FE8205-6F78-9C48-B15A-68E521E5072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08228" y="4096383"/>
            <a:ext cx="1984500" cy="1800000"/>
          </a:xfrm>
          <a:prstGeom prst="rect">
            <a:avLst/>
          </a:prstGeom>
        </p:spPr>
      </p:pic>
      <p:pic>
        <p:nvPicPr>
          <p:cNvPr id="22" name="Immagine 21">
            <a:extLst>
              <a:ext uri="{FF2B5EF4-FFF2-40B4-BE49-F238E27FC236}">
                <a16:creationId xmlns:a16="http://schemas.microsoft.com/office/drawing/2014/main" id="{F5D57A9C-0416-704B-BAE3-74C278DB5D9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93319" y="4096383"/>
            <a:ext cx="1908434" cy="1800000"/>
          </a:xfrm>
          <a:prstGeom prst="rect">
            <a:avLst/>
          </a:prstGeom>
        </p:spPr>
      </p:pic>
      <p:pic>
        <p:nvPicPr>
          <p:cNvPr id="23" name="Immagine 22">
            <a:extLst>
              <a:ext uri="{FF2B5EF4-FFF2-40B4-BE49-F238E27FC236}">
                <a16:creationId xmlns:a16="http://schemas.microsoft.com/office/drawing/2014/main" id="{480DEDBB-D292-0D4E-BED9-E051856FCAA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8609" y="5953454"/>
            <a:ext cx="1939500" cy="1800000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02FEBBA4-0834-21C6-B172-506760125A6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8609" y="153956"/>
            <a:ext cx="1980000" cy="1800000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069FAF65-E245-684B-3B7A-D10BCCB793E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41354" y="141093"/>
            <a:ext cx="1976382" cy="1800000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F224F169-FE9B-6B30-06F9-681D0883236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56986" y="153956"/>
            <a:ext cx="2021538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68567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ttangolo 14">
            <a:extLst>
              <a:ext uri="{FF2B5EF4-FFF2-40B4-BE49-F238E27FC236}">
                <a16:creationId xmlns:a16="http://schemas.microsoft.com/office/drawing/2014/main" id="{C83BBF40-519E-AC46-9017-8DF2CE791306}"/>
              </a:ext>
            </a:extLst>
          </p:cNvPr>
          <p:cNvSpPr/>
          <p:nvPr/>
        </p:nvSpPr>
        <p:spPr>
          <a:xfrm>
            <a:off x="0" y="7931648"/>
            <a:ext cx="6691395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3. Regulation of circulating metabolites (lipid fraction) in healthy and type 2 diabetes mellitus (T2D) individuals receiving anti-Influenza and anti-COVID-19 vaccination.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anges in metabolite levels of the lipid fraction were measured in  serum samples longitudinally collected in fasting condition from 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nly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 (in grey) and 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lus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s (in blue for healthy subjects, HS; in petrol green for T2D individuals) immediately before (day 0, d0), as well as 1 day and 30 days (d1 and d30, respectively) after the 3rd booster dose of anti-COVID-19 mRNA vaccine in presence or absence of anti-Flu vaccine. Only for 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efore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 (in light blue) the analysis was performed on sera stored before (d0) quadrivalent anti-Flu vaccine, as well as before (d30) and 1 and 30 days after (d30+1 and d30+30, respectively) the 3rd booster dose of anti-COVID-19 mRNA vaccine. Values are shown as percentage (%) of the metabolite level relative to total metabolites. P-values calculated by one-way ANOVA test were assigned as follows: * ≤ 0.05; ** ≤ 0.01; *** ≤ 0.001, **** ≤ 0.0001.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C1E9C374-8F62-7141-A3DE-5DEEF121E2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280" y="99749"/>
            <a:ext cx="2038500" cy="1800000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39172A04-9841-CC4A-B74F-7A2B212633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5780" y="99749"/>
            <a:ext cx="2065500" cy="1800000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57670394-ED0F-7C46-BCF8-B11EDB3920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09886" y="99749"/>
            <a:ext cx="2038500" cy="1800000"/>
          </a:xfrm>
          <a:prstGeom prst="rect">
            <a:avLst/>
          </a:prstGeom>
        </p:spPr>
      </p:pic>
      <p:pic>
        <p:nvPicPr>
          <p:cNvPr id="17" name="Immagine 16">
            <a:extLst>
              <a:ext uri="{FF2B5EF4-FFF2-40B4-BE49-F238E27FC236}">
                <a16:creationId xmlns:a16="http://schemas.microsoft.com/office/drawing/2014/main" id="{7B309F50-8A39-1540-90CD-CE5CE026256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7280" y="2109925"/>
            <a:ext cx="2006484" cy="1800000"/>
          </a:xfrm>
          <a:prstGeom prst="rect">
            <a:avLst/>
          </a:prstGeom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967A6A86-B07A-E446-854E-78111708B23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67671" y="2109925"/>
            <a:ext cx="2043609" cy="1800000"/>
          </a:xfrm>
          <a:prstGeom prst="rect">
            <a:avLst/>
          </a:prstGeom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1620D54D-8C7C-5647-9A47-A63573A7F1E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31845" y="2109925"/>
            <a:ext cx="2016541" cy="1800000"/>
          </a:xfrm>
          <a:prstGeom prst="rect">
            <a:avLst/>
          </a:prstGeom>
        </p:spPr>
      </p:pic>
      <p:pic>
        <p:nvPicPr>
          <p:cNvPr id="21" name="Immagine 20">
            <a:extLst>
              <a:ext uri="{FF2B5EF4-FFF2-40B4-BE49-F238E27FC236}">
                <a16:creationId xmlns:a16="http://schemas.microsoft.com/office/drawing/2014/main" id="{A52006D8-D0E2-764F-9DD7-288ABB2212A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0348" y="4065892"/>
            <a:ext cx="2033416" cy="1800000"/>
          </a:xfrm>
          <a:prstGeom prst="rect">
            <a:avLst/>
          </a:prstGeom>
        </p:spPr>
      </p:pic>
      <p:pic>
        <p:nvPicPr>
          <p:cNvPr id="25" name="Immagine 24">
            <a:extLst>
              <a:ext uri="{FF2B5EF4-FFF2-40B4-BE49-F238E27FC236}">
                <a16:creationId xmlns:a16="http://schemas.microsoft.com/office/drawing/2014/main" id="{6E1F45C6-E4A7-1641-9487-D99F8D6D458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45780" y="5975681"/>
            <a:ext cx="2001995" cy="1800000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0695EA3E-5B2A-9DBD-6164-99A9CE9ADB0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65180" y="4065892"/>
            <a:ext cx="2026700" cy="1800000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45273764-82DF-A5B7-89D2-1535C8CDBD5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09886" y="4053000"/>
            <a:ext cx="1920286" cy="1800000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98B5F554-0B4C-5756-6FEE-BFD4E019BDA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80348" y="5975681"/>
            <a:ext cx="2021608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12138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95E08DA7-8885-EF4B-93D9-95D3B9471B0D}"/>
              </a:ext>
            </a:extLst>
          </p:cNvPr>
          <p:cNvSpPr txBox="1"/>
          <p:nvPr/>
        </p:nvSpPr>
        <p:spPr>
          <a:xfrm>
            <a:off x="2583571" y="0"/>
            <a:ext cx="15279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lu</a:t>
            </a:r>
            <a:r>
              <a:rPr lang="it-IT" sz="14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plus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oV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(HS) 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CCAC41A0-A597-544E-8376-E8F50D27BA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5228" y="327987"/>
            <a:ext cx="1548000" cy="1086316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1FBA3DE6-487E-9149-8561-C9AC8636D9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5753" y="3909908"/>
            <a:ext cx="1548000" cy="1060274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46D95ED3-B61A-DB4E-9839-21EE3D371F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18305" y="3906449"/>
            <a:ext cx="1548000" cy="1060274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39C0CA29-9325-4A48-8EE3-9879A1FE7B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98921" y="3906449"/>
            <a:ext cx="1548000" cy="1060274"/>
          </a:xfrm>
          <a:prstGeom prst="rect">
            <a:avLst/>
          </a:prstGeom>
        </p:spPr>
      </p:pic>
      <p:pic>
        <p:nvPicPr>
          <p:cNvPr id="15" name="Immagine 14">
            <a:extLst>
              <a:ext uri="{FF2B5EF4-FFF2-40B4-BE49-F238E27FC236}">
                <a16:creationId xmlns:a16="http://schemas.microsoft.com/office/drawing/2014/main" id="{FB1CE867-D63C-2C40-8554-5871AD0A91D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37686" y="3908200"/>
            <a:ext cx="1548000" cy="1060274"/>
          </a:xfrm>
          <a:prstGeom prst="rect">
            <a:avLst/>
          </a:prstGeom>
        </p:spPr>
      </p:pic>
      <p:pic>
        <p:nvPicPr>
          <p:cNvPr id="18" name="Immagine 17">
            <a:extLst>
              <a:ext uri="{FF2B5EF4-FFF2-40B4-BE49-F238E27FC236}">
                <a16:creationId xmlns:a16="http://schemas.microsoft.com/office/drawing/2014/main" id="{D6B9EB9C-54BA-2849-B14D-A63AC87E7F8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52858" y="3915556"/>
            <a:ext cx="1548000" cy="1060274"/>
          </a:xfrm>
          <a:prstGeom prst="rect">
            <a:avLst/>
          </a:prstGeom>
        </p:spPr>
      </p:pic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85ECD73D-CEFD-3D49-A9C7-94D8C1D61569}"/>
              </a:ext>
            </a:extLst>
          </p:cNvPr>
          <p:cNvSpPr txBox="1"/>
          <p:nvPr/>
        </p:nvSpPr>
        <p:spPr>
          <a:xfrm>
            <a:off x="-14641" y="2027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5A5BE4BC-111F-0241-B68B-F28A56F4F33E}"/>
              </a:ext>
            </a:extLst>
          </p:cNvPr>
          <p:cNvSpPr txBox="1"/>
          <p:nvPr/>
        </p:nvSpPr>
        <p:spPr>
          <a:xfrm>
            <a:off x="-14641" y="125567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89536516-35E1-F340-9289-87B61A8FA49D}"/>
              </a:ext>
            </a:extLst>
          </p:cNvPr>
          <p:cNvSpPr txBox="1"/>
          <p:nvPr/>
        </p:nvSpPr>
        <p:spPr>
          <a:xfrm>
            <a:off x="-52128" y="246381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C0867E71-5D23-6A45-AAF5-52F87A5B5090}"/>
              </a:ext>
            </a:extLst>
          </p:cNvPr>
          <p:cNvSpPr txBox="1"/>
          <p:nvPr/>
        </p:nvSpPr>
        <p:spPr>
          <a:xfrm>
            <a:off x="-14641" y="359266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B1E40ED5-B6F4-0541-B664-D2D34EAEC41D}"/>
              </a:ext>
            </a:extLst>
          </p:cNvPr>
          <p:cNvSpPr txBox="1"/>
          <p:nvPr/>
        </p:nvSpPr>
        <p:spPr>
          <a:xfrm>
            <a:off x="-7374" y="48792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30" name="Immagine 29">
            <a:extLst>
              <a:ext uri="{FF2B5EF4-FFF2-40B4-BE49-F238E27FC236}">
                <a16:creationId xmlns:a16="http://schemas.microsoft.com/office/drawing/2014/main" id="{3CF17EDA-9E85-D84B-A594-5CCF066FACC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84221" y="342175"/>
            <a:ext cx="1548000" cy="1082517"/>
          </a:xfrm>
          <a:prstGeom prst="rect">
            <a:avLst/>
          </a:prstGeom>
        </p:spPr>
      </p:pic>
      <p:pic>
        <p:nvPicPr>
          <p:cNvPr id="32" name="Immagine 31">
            <a:extLst>
              <a:ext uri="{FF2B5EF4-FFF2-40B4-BE49-F238E27FC236}">
                <a16:creationId xmlns:a16="http://schemas.microsoft.com/office/drawing/2014/main" id="{786624EE-F50B-1B4E-89D8-DFEF5BFA47B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17775" y="350138"/>
            <a:ext cx="1548000" cy="1082517"/>
          </a:xfrm>
          <a:prstGeom prst="rect">
            <a:avLst/>
          </a:prstGeom>
        </p:spPr>
      </p:pic>
      <p:pic>
        <p:nvPicPr>
          <p:cNvPr id="33" name="Immagine 32">
            <a:extLst>
              <a:ext uri="{FF2B5EF4-FFF2-40B4-BE49-F238E27FC236}">
                <a16:creationId xmlns:a16="http://schemas.microsoft.com/office/drawing/2014/main" id="{1D89F199-E323-2846-9120-94837805BED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51329" y="342175"/>
            <a:ext cx="1548000" cy="1082517"/>
          </a:xfrm>
          <a:prstGeom prst="rect">
            <a:avLst/>
          </a:prstGeom>
        </p:spPr>
      </p:pic>
      <p:pic>
        <p:nvPicPr>
          <p:cNvPr id="34" name="Immagine 33">
            <a:extLst>
              <a:ext uri="{FF2B5EF4-FFF2-40B4-BE49-F238E27FC236}">
                <a16:creationId xmlns:a16="http://schemas.microsoft.com/office/drawing/2014/main" id="{9567EB43-151F-7443-9BD0-B34750866FA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384883" y="347105"/>
            <a:ext cx="1548000" cy="1082517"/>
          </a:xfrm>
          <a:prstGeom prst="rect">
            <a:avLst/>
          </a:prstGeom>
        </p:spPr>
      </p:pic>
      <p:pic>
        <p:nvPicPr>
          <p:cNvPr id="37" name="Immagine 36">
            <a:extLst>
              <a:ext uri="{FF2B5EF4-FFF2-40B4-BE49-F238E27FC236}">
                <a16:creationId xmlns:a16="http://schemas.microsoft.com/office/drawing/2014/main" id="{67A5A4DC-6DB7-D846-8DCC-A9672F77A5A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368319" y="1546425"/>
            <a:ext cx="1548000" cy="1071281"/>
          </a:xfrm>
          <a:prstGeom prst="rect">
            <a:avLst/>
          </a:prstGeom>
        </p:spPr>
      </p:pic>
      <p:pic>
        <p:nvPicPr>
          <p:cNvPr id="38" name="Immagine 37">
            <a:extLst>
              <a:ext uri="{FF2B5EF4-FFF2-40B4-BE49-F238E27FC236}">
                <a16:creationId xmlns:a16="http://schemas.microsoft.com/office/drawing/2014/main" id="{C86BC4F9-2EB8-5443-A217-1C13DE77ACD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96321" y="1532175"/>
            <a:ext cx="1548000" cy="1082517"/>
          </a:xfrm>
          <a:prstGeom prst="rect">
            <a:avLst/>
          </a:prstGeom>
        </p:spPr>
      </p:pic>
      <p:pic>
        <p:nvPicPr>
          <p:cNvPr id="39" name="Immagine 38">
            <a:extLst>
              <a:ext uri="{FF2B5EF4-FFF2-40B4-BE49-F238E27FC236}">
                <a16:creationId xmlns:a16="http://schemas.microsoft.com/office/drawing/2014/main" id="{B919372B-9A2B-3548-BB72-90B2B7238FBD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35427" y="1557364"/>
            <a:ext cx="1548000" cy="1082517"/>
          </a:xfrm>
          <a:prstGeom prst="rect">
            <a:avLst/>
          </a:prstGeom>
        </p:spPr>
      </p:pic>
      <p:pic>
        <p:nvPicPr>
          <p:cNvPr id="40" name="Immagine 39">
            <a:extLst>
              <a:ext uri="{FF2B5EF4-FFF2-40B4-BE49-F238E27FC236}">
                <a16:creationId xmlns:a16="http://schemas.microsoft.com/office/drawing/2014/main" id="{52A0A88E-4EA8-3046-ACB6-1424F29B74E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363117" y="1494686"/>
            <a:ext cx="1548000" cy="1114993"/>
          </a:xfrm>
          <a:prstGeom prst="rect">
            <a:avLst/>
          </a:prstGeom>
        </p:spPr>
      </p:pic>
      <p:pic>
        <p:nvPicPr>
          <p:cNvPr id="41" name="Immagine 40">
            <a:extLst>
              <a:ext uri="{FF2B5EF4-FFF2-40B4-BE49-F238E27FC236}">
                <a16:creationId xmlns:a16="http://schemas.microsoft.com/office/drawing/2014/main" id="{6F781011-D2C8-DA47-995C-EA958F630A6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-11396" y="1538648"/>
            <a:ext cx="1548000" cy="1082517"/>
          </a:xfrm>
          <a:prstGeom prst="rect">
            <a:avLst/>
          </a:prstGeom>
        </p:spPr>
      </p:pic>
      <p:pic>
        <p:nvPicPr>
          <p:cNvPr id="42" name="Immagine 41">
            <a:extLst>
              <a:ext uri="{FF2B5EF4-FFF2-40B4-BE49-F238E27FC236}">
                <a16:creationId xmlns:a16="http://schemas.microsoft.com/office/drawing/2014/main" id="{F5EAC059-9A8A-7543-908C-6BA73DB058E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334207" y="5232201"/>
            <a:ext cx="1548000" cy="1038926"/>
          </a:xfrm>
          <a:prstGeom prst="rect">
            <a:avLst/>
          </a:prstGeom>
        </p:spPr>
      </p:pic>
      <p:pic>
        <p:nvPicPr>
          <p:cNvPr id="43" name="Immagine 42">
            <a:extLst>
              <a:ext uri="{FF2B5EF4-FFF2-40B4-BE49-F238E27FC236}">
                <a16:creationId xmlns:a16="http://schemas.microsoft.com/office/drawing/2014/main" id="{E6B8DCE2-6F6D-5741-A69C-F06F6DD84E9B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723418" y="5227006"/>
            <a:ext cx="1548000" cy="1049315"/>
          </a:xfrm>
          <a:prstGeom prst="rect">
            <a:avLst/>
          </a:prstGeom>
        </p:spPr>
      </p:pic>
      <p:pic>
        <p:nvPicPr>
          <p:cNvPr id="44" name="Immagine 43">
            <a:extLst>
              <a:ext uri="{FF2B5EF4-FFF2-40B4-BE49-F238E27FC236}">
                <a16:creationId xmlns:a16="http://schemas.microsoft.com/office/drawing/2014/main" id="{41EB0B1E-6333-FB44-BE43-A2A450E10723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053588" y="5213849"/>
            <a:ext cx="1548000" cy="1038926"/>
          </a:xfrm>
          <a:prstGeom prst="rect">
            <a:avLst/>
          </a:prstGeom>
        </p:spPr>
      </p:pic>
      <p:pic>
        <p:nvPicPr>
          <p:cNvPr id="45" name="Immagine 44">
            <a:extLst>
              <a:ext uri="{FF2B5EF4-FFF2-40B4-BE49-F238E27FC236}">
                <a16:creationId xmlns:a16="http://schemas.microsoft.com/office/drawing/2014/main" id="{7C0E1720-D74B-4847-B85F-0A59D1BA88D4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368760" y="5190303"/>
            <a:ext cx="1548000" cy="1038926"/>
          </a:xfrm>
          <a:prstGeom prst="rect">
            <a:avLst/>
          </a:prstGeom>
        </p:spPr>
      </p:pic>
      <p:pic>
        <p:nvPicPr>
          <p:cNvPr id="46" name="Immagine 45">
            <a:extLst>
              <a:ext uri="{FF2B5EF4-FFF2-40B4-BE49-F238E27FC236}">
                <a16:creationId xmlns:a16="http://schemas.microsoft.com/office/drawing/2014/main" id="{AE456947-0ABC-A24D-BEC3-7DFB8D9D4CB4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-4458" y="5213849"/>
            <a:ext cx="1548000" cy="1038926"/>
          </a:xfrm>
          <a:prstGeom prst="rect">
            <a:avLst/>
          </a:prstGeom>
        </p:spPr>
      </p:pic>
      <p:sp>
        <p:nvSpPr>
          <p:cNvPr id="29" name="Rettangolo 28">
            <a:extLst>
              <a:ext uri="{FF2B5EF4-FFF2-40B4-BE49-F238E27FC236}">
                <a16:creationId xmlns:a16="http://schemas.microsoft.com/office/drawing/2014/main" id="{B13071A5-63BA-8841-860A-440C4E3F1260}"/>
              </a:ext>
            </a:extLst>
          </p:cNvPr>
          <p:cNvSpPr/>
          <p:nvPr/>
        </p:nvSpPr>
        <p:spPr>
          <a:xfrm>
            <a:off x="78627" y="7719238"/>
            <a:ext cx="6724996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4. Correlation of anti-Influenza and anti-COVID-19 vaccine-specific antibody production with early innate cytokine/chemokine signature in healthy vaccine recipients. 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rrelations between Levels of binding class G immunoglobulins recognizing anti-SARS-CoV-2 trimeric Spike protein (anti-SARS-CoV-2 S) and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pecific anti-influenza (Flu) antibodies against all the vaccine antigen components included in the </a:t>
            </a:r>
            <a:r>
              <a:rPr lang="en-GB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celvax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Quadrivalent Influenza vaccine used in the 2021/2022 season (A/Wisconsin, A/Cambodia, B/Phuket and B/Washington) were measured at day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0 (d30) after the 3</a:t>
            </a:r>
            <a:r>
              <a:rPr lang="en-US" sz="11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d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ooster dose of anti-COVID-19 mRNA vaccine simultaneously administered with anti-Flu vaccine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althy subjects (HS) enrolled in the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lus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s. Correlation between antibody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tres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serum level of cytokines (IL-15, IL-6, TNF-</a:t>
            </a:r>
            <a:r>
              <a:rPr lang="en-US" sz="1100" dirty="0"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FN-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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-D)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the chemokine CXCL-10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E)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the inflammatory factor PTX3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F)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easured 1 day (d1) after simultaneous anti-Flu/COVID-19 vaccination was obtained by deriving a Pearson r correlation coefficient and reported as single linear regression curves. P-values and 99% confidence bands of the best fit-line are also shown for each slope. 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7B8234DA-D849-C64B-865F-E4A2B3A73F48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-7951" y="6447332"/>
            <a:ext cx="1548000" cy="1082517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E417CCED-EEAD-A744-A5E8-A63927CDAB51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355973" y="6451059"/>
            <a:ext cx="1548000" cy="1082517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B7F98838-73DC-D24D-A857-F71C527C66B6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2745693" y="6462002"/>
            <a:ext cx="1548000" cy="1082517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2C5BED02-98CD-1643-B76F-D92D78EAE6DC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075354" y="6461072"/>
            <a:ext cx="1548000" cy="1082517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E124A799-28A4-A648-8F8B-873F25912405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390526" y="6480983"/>
            <a:ext cx="1548000" cy="1082517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F7A65AE5-EA93-E892-1561-8103EF2049AC}"/>
              </a:ext>
            </a:extLst>
          </p:cNvPr>
          <p:cNvSpPr txBox="1"/>
          <p:nvPr/>
        </p:nvSpPr>
        <p:spPr>
          <a:xfrm>
            <a:off x="-17930" y="6190095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7ADEAA3E-ED4F-97CA-4D4F-652E6A0DC2CC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6887" y="2735121"/>
            <a:ext cx="1544400" cy="1080000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D140CA18-A090-9BCE-7487-5ED3C0D41DD0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392359" y="2722366"/>
            <a:ext cx="1552836" cy="1080000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A7F9C7F5-0726-9730-FB2B-840796A4D7DD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2756267" y="2736425"/>
            <a:ext cx="1544400" cy="1080000"/>
          </a:xfrm>
          <a:prstGeom prst="rect">
            <a:avLst/>
          </a:prstGeom>
        </p:spPr>
      </p:pic>
      <p:pic>
        <p:nvPicPr>
          <p:cNvPr id="17" name="Immagine 16">
            <a:extLst>
              <a:ext uri="{FF2B5EF4-FFF2-40B4-BE49-F238E27FC236}">
                <a16:creationId xmlns:a16="http://schemas.microsoft.com/office/drawing/2014/main" id="{040540BA-9773-CBED-3E4F-C8252D58376A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4078205" y="2739718"/>
            <a:ext cx="1545149" cy="1080000"/>
          </a:xfrm>
          <a:prstGeom prst="rect">
            <a:avLst/>
          </a:prstGeom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F47B4BEF-CF0D-995D-B8F7-0E767E38DBE5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5401593" y="2735121"/>
            <a:ext cx="1544400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02040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7D2F0A33-5C33-824E-A2CE-24CE59D9E186}"/>
              </a:ext>
            </a:extLst>
          </p:cNvPr>
          <p:cNvSpPr txBox="1"/>
          <p:nvPr/>
        </p:nvSpPr>
        <p:spPr>
          <a:xfrm>
            <a:off x="2742472" y="0"/>
            <a:ext cx="16161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lu</a:t>
            </a:r>
            <a:r>
              <a:rPr lang="it-IT" sz="14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plus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oV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(T2D) </a:t>
            </a: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0394C205-A133-F046-AF5F-7D9D51AD51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0312" y="321728"/>
            <a:ext cx="1548000" cy="1097178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610261D9-10D7-6243-8DFC-C0226E9F89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4359" y="1534417"/>
            <a:ext cx="1548000" cy="1082517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DFED0214-93A0-824B-8D8D-BB05067C29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73735" y="3895803"/>
            <a:ext cx="1548000" cy="1049492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DE786C7C-8EAA-4945-9501-C7DB0A349B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62166" y="321728"/>
            <a:ext cx="1548000" cy="1097178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3133583C-E6A2-654A-843A-9D6354C6C1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18421" y="1539468"/>
            <a:ext cx="1548000" cy="1093343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EDE163D9-52DB-CE45-85CF-5BDC29C1D91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57786" y="3881015"/>
            <a:ext cx="1548000" cy="1076178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D2CDF14D-D1DA-8E48-9B1D-06DDC7BCBF1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14532" y="314013"/>
            <a:ext cx="1548000" cy="1102611"/>
          </a:xfrm>
          <a:prstGeom prst="rect">
            <a:avLst/>
          </a:prstGeom>
        </p:spPr>
      </p:pic>
      <p:pic>
        <p:nvPicPr>
          <p:cNvPr id="17" name="Immagine 16">
            <a:extLst>
              <a:ext uri="{FF2B5EF4-FFF2-40B4-BE49-F238E27FC236}">
                <a16:creationId xmlns:a16="http://schemas.microsoft.com/office/drawing/2014/main" id="{7AE548E0-8617-9E49-BCA5-ADFF865EFD1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62114" y="1556748"/>
            <a:ext cx="1548000" cy="1082517"/>
          </a:xfrm>
          <a:prstGeom prst="rect">
            <a:avLst/>
          </a:prstGeom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CFB8A8B5-686A-D044-82DF-B874A753012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20148" y="3903373"/>
            <a:ext cx="1548000" cy="1060274"/>
          </a:xfrm>
          <a:prstGeom prst="rect">
            <a:avLst/>
          </a:prstGeom>
        </p:spPr>
      </p:pic>
      <p:pic>
        <p:nvPicPr>
          <p:cNvPr id="21" name="Immagine 20">
            <a:extLst>
              <a:ext uri="{FF2B5EF4-FFF2-40B4-BE49-F238E27FC236}">
                <a16:creationId xmlns:a16="http://schemas.microsoft.com/office/drawing/2014/main" id="{FDE26A74-D97D-B643-9BBB-7A4CFFF9835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088349" y="322160"/>
            <a:ext cx="1548000" cy="1086316"/>
          </a:xfrm>
          <a:prstGeom prst="rect">
            <a:avLst/>
          </a:prstGeom>
        </p:spPr>
      </p:pic>
      <p:pic>
        <p:nvPicPr>
          <p:cNvPr id="22" name="Immagine 21">
            <a:extLst>
              <a:ext uri="{FF2B5EF4-FFF2-40B4-BE49-F238E27FC236}">
                <a16:creationId xmlns:a16="http://schemas.microsoft.com/office/drawing/2014/main" id="{05A9ABDE-785B-2449-A24A-A1E5603A730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423898" y="1544880"/>
            <a:ext cx="1548000" cy="1082517"/>
          </a:xfrm>
          <a:prstGeom prst="rect">
            <a:avLst/>
          </a:prstGeom>
        </p:spPr>
      </p:pic>
      <p:pic>
        <p:nvPicPr>
          <p:cNvPr id="23" name="Immagine 22">
            <a:extLst>
              <a:ext uri="{FF2B5EF4-FFF2-40B4-BE49-F238E27FC236}">
                <a16:creationId xmlns:a16="http://schemas.microsoft.com/office/drawing/2014/main" id="{DFEB7AF0-CFCD-AE48-BE16-524CE8885E1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423898" y="3895803"/>
            <a:ext cx="1548000" cy="1060274"/>
          </a:xfrm>
          <a:prstGeom prst="rect">
            <a:avLst/>
          </a:prstGeom>
        </p:spPr>
      </p:pic>
      <p:pic>
        <p:nvPicPr>
          <p:cNvPr id="25" name="Immagine 24">
            <a:extLst>
              <a:ext uri="{FF2B5EF4-FFF2-40B4-BE49-F238E27FC236}">
                <a16:creationId xmlns:a16="http://schemas.microsoft.com/office/drawing/2014/main" id="{F19F0BD6-D522-7742-9B84-271B51DF1E1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-9334" y="338646"/>
            <a:ext cx="1548000" cy="1086316"/>
          </a:xfrm>
          <a:prstGeom prst="rect">
            <a:avLst/>
          </a:prstGeom>
        </p:spPr>
      </p:pic>
      <p:pic>
        <p:nvPicPr>
          <p:cNvPr id="26" name="Immagine 25">
            <a:extLst>
              <a:ext uri="{FF2B5EF4-FFF2-40B4-BE49-F238E27FC236}">
                <a16:creationId xmlns:a16="http://schemas.microsoft.com/office/drawing/2014/main" id="{29AC7BFC-015F-4840-8DC2-5971426FE5A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-9334" y="1535506"/>
            <a:ext cx="1548000" cy="1082517"/>
          </a:xfrm>
          <a:prstGeom prst="rect">
            <a:avLst/>
          </a:prstGeom>
        </p:spPr>
      </p:pic>
      <p:pic>
        <p:nvPicPr>
          <p:cNvPr id="27" name="Immagine 26">
            <a:extLst>
              <a:ext uri="{FF2B5EF4-FFF2-40B4-BE49-F238E27FC236}">
                <a16:creationId xmlns:a16="http://schemas.microsoft.com/office/drawing/2014/main" id="{9F228250-4A6B-BA4A-AFA4-24F641D915C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1373" y="3881015"/>
            <a:ext cx="1548000" cy="1060274"/>
          </a:xfrm>
          <a:prstGeom prst="rect">
            <a:avLst/>
          </a:prstGeom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14C7A5C6-0B11-CA4C-ADAC-479A8F47C66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-9334" y="5234223"/>
            <a:ext cx="1548000" cy="1049492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80E5828B-3216-5742-8DF3-0302C18D764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423898" y="5224339"/>
            <a:ext cx="1548000" cy="1038926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CFB04AB4-206E-1447-9F7F-8CB6196F0FC6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088349" y="5198037"/>
            <a:ext cx="1548000" cy="1085678"/>
          </a:xfrm>
          <a:prstGeom prst="rect">
            <a:avLst/>
          </a:prstGeom>
        </p:spPr>
      </p:pic>
      <p:pic>
        <p:nvPicPr>
          <p:cNvPr id="18" name="Immagine 17">
            <a:extLst>
              <a:ext uri="{FF2B5EF4-FFF2-40B4-BE49-F238E27FC236}">
                <a16:creationId xmlns:a16="http://schemas.microsoft.com/office/drawing/2014/main" id="{1AF2B055-D8BE-A64B-A1D1-B9F28C1AEEF6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742472" y="5226985"/>
            <a:ext cx="1548000" cy="1049315"/>
          </a:xfrm>
          <a:prstGeom prst="rect">
            <a:avLst/>
          </a:prstGeom>
        </p:spPr>
      </p:pic>
      <p:pic>
        <p:nvPicPr>
          <p:cNvPr id="28" name="Immagine 27">
            <a:extLst>
              <a:ext uri="{FF2B5EF4-FFF2-40B4-BE49-F238E27FC236}">
                <a16:creationId xmlns:a16="http://schemas.microsoft.com/office/drawing/2014/main" id="{E4274881-D6E5-0B46-8BB3-8322B9A3EC8D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334359" y="5237374"/>
            <a:ext cx="1548000" cy="1038926"/>
          </a:xfrm>
          <a:prstGeom prst="rect">
            <a:avLst/>
          </a:prstGeom>
        </p:spPr>
      </p:pic>
      <p:sp>
        <p:nvSpPr>
          <p:cNvPr id="30" name="Rettangolo 29">
            <a:extLst>
              <a:ext uri="{FF2B5EF4-FFF2-40B4-BE49-F238E27FC236}">
                <a16:creationId xmlns:a16="http://schemas.microsoft.com/office/drawing/2014/main" id="{748AD74D-B65D-3D46-870D-5E0943F338E5}"/>
              </a:ext>
            </a:extLst>
          </p:cNvPr>
          <p:cNvSpPr/>
          <p:nvPr/>
        </p:nvSpPr>
        <p:spPr>
          <a:xfrm>
            <a:off x="33463" y="7613065"/>
            <a:ext cx="6724996" cy="22929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</a:t>
            </a:r>
            <a:r>
              <a:rPr lang="en-US" sz="1100" b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Correlation of anti-Influenza and anti-COVID-19 vaccine-specific antibody production with early innate cytokine/chemokine signature in type 2 diabetes mellitus (T2D) vaccine recipients. 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rrelations between Levels of binding class G immunoglobulins recognizing anti-SARS-CoV-2 trimeric Spike protein (anti-SARS-CoV-2 S) and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pecific anti-influenza (Flu) antibodies against all the vaccine antigen components included in the </a:t>
            </a:r>
            <a:r>
              <a:rPr lang="en-GB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celvax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Quadrivalent Influenza vaccine used in the 2021/2022 season (A/Wisconsin, A/Cambodia, B/Phuket and B/Washington) were measured at day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0 (d30) after the 3</a:t>
            </a:r>
            <a:r>
              <a:rPr lang="en-US" sz="11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d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ooster dose of anti-COVID-19 mRNA vaccine simultaneously administered with anti-Flu vaccine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2D subjects enrolled in the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“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u</a:t>
            </a:r>
            <a:r>
              <a:rPr lang="en-US" sz="1100" i="1" baseline="-25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lus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” groups. Correlation between antibody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tres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serum level of cytokines (IL-15, IL-6, TNF-</a:t>
            </a:r>
            <a:r>
              <a:rPr lang="en-US" sz="1100" dirty="0"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FN-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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-D)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the chemokine CXCL-10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E)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the inflammatory factor PTX3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F)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asured 1 day (d1) after simultaneous anti-Flu/COVID-19 vaccination was obtained by deriving a Pearson r correlation coefficient and reported as single linear regression curves. P-values and 99% confidence bands of the best fit-line are also shown for each slope. </a:t>
            </a:r>
            <a:endParaRPr lang="it-IT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55CCB53D-CB04-054D-AE10-E9C95BFB9026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390312" y="6484777"/>
            <a:ext cx="1548000" cy="1082517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A2B97364-00CB-9146-94CB-2969CA4CA55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718421" y="6478152"/>
            <a:ext cx="1548000" cy="1082517"/>
          </a:xfrm>
          <a:prstGeom prst="rect">
            <a:avLst/>
          </a:prstGeom>
        </p:spPr>
      </p:pic>
      <p:pic>
        <p:nvPicPr>
          <p:cNvPr id="15" name="Immagine 14">
            <a:extLst>
              <a:ext uri="{FF2B5EF4-FFF2-40B4-BE49-F238E27FC236}">
                <a16:creationId xmlns:a16="http://schemas.microsoft.com/office/drawing/2014/main" id="{90A9B620-1C03-0A45-9604-5D6FAD5339DF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062114" y="6487822"/>
            <a:ext cx="1548000" cy="1082517"/>
          </a:xfrm>
          <a:prstGeom prst="rect">
            <a:avLst/>
          </a:prstGeom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0C46F655-308C-B04C-A617-9ECD2CF9B639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423898" y="6484776"/>
            <a:ext cx="1548000" cy="1082517"/>
          </a:xfrm>
          <a:prstGeom prst="rect">
            <a:avLst/>
          </a:prstGeom>
        </p:spPr>
      </p:pic>
      <p:pic>
        <p:nvPicPr>
          <p:cNvPr id="24" name="Immagine 23">
            <a:extLst>
              <a:ext uri="{FF2B5EF4-FFF2-40B4-BE49-F238E27FC236}">
                <a16:creationId xmlns:a16="http://schemas.microsoft.com/office/drawing/2014/main" id="{942552C1-25B2-8B4E-B46F-9B346768FF46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2200" y="6478153"/>
            <a:ext cx="1548000" cy="1082517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D8D37614-F295-24A5-B692-F5B95703EA22}"/>
              </a:ext>
            </a:extLst>
          </p:cNvPr>
          <p:cNvSpPr txBox="1"/>
          <p:nvPr/>
        </p:nvSpPr>
        <p:spPr>
          <a:xfrm>
            <a:off x="0" y="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447DCC3B-32C3-2EDB-FBF2-1A3B96A026F9}"/>
              </a:ext>
            </a:extLst>
          </p:cNvPr>
          <p:cNvSpPr txBox="1"/>
          <p:nvPr/>
        </p:nvSpPr>
        <p:spPr>
          <a:xfrm>
            <a:off x="0" y="123540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9ABA4FB6-9E46-5FF7-0387-289D228B8CFE}"/>
              </a:ext>
            </a:extLst>
          </p:cNvPr>
          <p:cNvSpPr txBox="1"/>
          <p:nvPr/>
        </p:nvSpPr>
        <p:spPr>
          <a:xfrm>
            <a:off x="-37487" y="24435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B506EED0-1C0D-DC71-718B-A0C29FD6B22B}"/>
              </a:ext>
            </a:extLst>
          </p:cNvPr>
          <p:cNvSpPr txBox="1"/>
          <p:nvPr/>
        </p:nvSpPr>
        <p:spPr>
          <a:xfrm>
            <a:off x="0" y="357239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1E361B09-CFA9-125A-0615-2233BA07255B}"/>
              </a:ext>
            </a:extLst>
          </p:cNvPr>
          <p:cNvSpPr txBox="1"/>
          <p:nvPr/>
        </p:nvSpPr>
        <p:spPr>
          <a:xfrm>
            <a:off x="7267" y="48589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EADC13AC-1B73-7AEA-D471-EE359A7D5C28}"/>
              </a:ext>
            </a:extLst>
          </p:cNvPr>
          <p:cNvSpPr txBox="1"/>
          <p:nvPr/>
        </p:nvSpPr>
        <p:spPr>
          <a:xfrm>
            <a:off x="-3289" y="616982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40" name="Immagine 39">
            <a:extLst>
              <a:ext uri="{FF2B5EF4-FFF2-40B4-BE49-F238E27FC236}">
                <a16:creationId xmlns:a16="http://schemas.microsoft.com/office/drawing/2014/main" id="{F08A9677-4DE8-CA0E-1C8B-E506ED0D6E7E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1393912" y="2768563"/>
            <a:ext cx="1544400" cy="1080000"/>
          </a:xfrm>
          <a:prstGeom prst="rect">
            <a:avLst/>
          </a:prstGeom>
        </p:spPr>
      </p:pic>
      <p:pic>
        <p:nvPicPr>
          <p:cNvPr id="41" name="Immagine 40">
            <a:extLst>
              <a:ext uri="{FF2B5EF4-FFF2-40B4-BE49-F238E27FC236}">
                <a16:creationId xmlns:a16="http://schemas.microsoft.com/office/drawing/2014/main" id="{3DA33650-FE0D-9759-B88C-0440333C07EC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778346" y="2768563"/>
            <a:ext cx="1544400" cy="1080000"/>
          </a:xfrm>
          <a:prstGeom prst="rect">
            <a:avLst/>
          </a:prstGeom>
        </p:spPr>
      </p:pic>
      <p:pic>
        <p:nvPicPr>
          <p:cNvPr id="42" name="Immagine 41">
            <a:extLst>
              <a:ext uri="{FF2B5EF4-FFF2-40B4-BE49-F238E27FC236}">
                <a16:creationId xmlns:a16="http://schemas.microsoft.com/office/drawing/2014/main" id="{84576B54-D272-0F5B-9950-1B20DC2F48C9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4116629" y="2777601"/>
            <a:ext cx="1544400" cy="1080000"/>
          </a:xfrm>
          <a:prstGeom prst="rect">
            <a:avLst/>
          </a:prstGeom>
        </p:spPr>
      </p:pic>
      <p:pic>
        <p:nvPicPr>
          <p:cNvPr id="43" name="Immagine 42">
            <a:extLst>
              <a:ext uri="{FF2B5EF4-FFF2-40B4-BE49-F238E27FC236}">
                <a16:creationId xmlns:a16="http://schemas.microsoft.com/office/drawing/2014/main" id="{740C4C59-EFC9-F3FB-FD6A-CC5554CE9ED2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5442789" y="2751319"/>
            <a:ext cx="1529109" cy="1080000"/>
          </a:xfrm>
          <a:prstGeom prst="rect">
            <a:avLst/>
          </a:prstGeom>
        </p:spPr>
      </p:pic>
      <p:pic>
        <p:nvPicPr>
          <p:cNvPr id="44" name="Immagine 43">
            <a:extLst>
              <a:ext uri="{FF2B5EF4-FFF2-40B4-BE49-F238E27FC236}">
                <a16:creationId xmlns:a16="http://schemas.microsoft.com/office/drawing/2014/main" id="{146371FE-14DD-8E66-CA6F-B977E46F13E2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35800" y="2752167"/>
            <a:ext cx="1544400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431885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6</TotalTime>
  <Words>1086</Words>
  <Application>Microsoft Office PowerPoint</Application>
  <PresentationFormat>A4 Paper (210x297 mm)</PresentationFormat>
  <Paragraphs>2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evera Martina</dc:creator>
  <cp:lastModifiedBy>Petar Dobricanin</cp:lastModifiedBy>
  <cp:revision>139</cp:revision>
  <dcterms:created xsi:type="dcterms:W3CDTF">2023-10-20T14:04:01Z</dcterms:created>
  <dcterms:modified xsi:type="dcterms:W3CDTF">2024-09-13T16:10:58Z</dcterms:modified>
</cp:coreProperties>
</file>